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30E25-325E-4E81-9712-4FE54428C2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79275-DB64-451C-8613-9BCE5BE266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DAF21-9764-4118-BC27-DD4A6CD2A9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57C18-5BD6-4BE8-9DEA-D35B57B6D8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671ED-4427-412B-8C43-D07C3994C6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D5754-0004-41B2-8D9F-C6D18475CC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25F6F-CE60-4F5A-8979-4B9EA7C3E7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D78E7-87FF-4B56-B56D-17BDDAB7D5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251A6-4ACE-4E53-A5BF-48D742DD0B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E2646-A415-4B06-A8BB-980EFAAC6E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C17D3-6B0A-437E-85AE-B82E38D58C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F7E0D-5643-482E-A171-92A407FFFB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BA7B9A-C2A9-419A-9146-626CA9E530EC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5"/>
          <p:cNvSpPr/>
          <p:nvPr/>
        </p:nvSpPr>
        <p:spPr>
          <a:xfrm>
            <a:off x="68400" y="3114720"/>
            <a:ext cx="674352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: Figure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Rα and ERβ Western Blot analysis of T-cell lysates from SLE patients and healthy controls. The expression of ERα and ERβ was evaluated in T lymphocytes from SLE patients, divided in patients with SLEDAI-2K scores &lt; 6  and ≥ 6, and healthy controls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5 subjects for group)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ta from representative subjects are shown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ensitometry analysis of protein levels relative to GAPDH is also shown. Values are expressed as mean ± SD. Statistical differences were calculated by the Mann-Whitney U test. 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01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rs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ealthy controls and patients with SLEDAI-2K scores &lt; 6. Ctrs, healthy contro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5"/>
          <p:cNvGrpSpPr/>
          <p:nvPr/>
        </p:nvGrpSpPr>
        <p:grpSpPr>
          <a:xfrm>
            <a:off x="256320" y="395280"/>
            <a:ext cx="6409440" cy="2591640"/>
            <a:chOff x="256320" y="395280"/>
            <a:chExt cx="6409440" cy="2591640"/>
          </a:xfrm>
        </p:grpSpPr>
        <p:grpSp>
          <p:nvGrpSpPr>
            <p:cNvPr id="43" name="Gruppo 4"/>
            <p:cNvGrpSpPr/>
            <p:nvPr/>
          </p:nvGrpSpPr>
          <p:grpSpPr>
            <a:xfrm>
              <a:off x="325800" y="861840"/>
              <a:ext cx="2887560" cy="2125080"/>
              <a:chOff x="325800" y="861840"/>
              <a:chExt cx="2887560" cy="2125080"/>
            </a:xfrm>
          </p:grpSpPr>
          <p:pic>
            <p:nvPicPr>
              <p:cNvPr id="44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1621080" y="1927080"/>
                <a:ext cx="1592280" cy="431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CasellaDiTesto 29"/>
              <p:cNvSpPr/>
              <p:nvPr/>
            </p:nvSpPr>
            <p:spPr>
              <a:xfrm>
                <a:off x="325800" y="1933560"/>
                <a:ext cx="637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APD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CasellaDiTesto 30"/>
              <p:cNvSpPr/>
              <p:nvPr/>
            </p:nvSpPr>
            <p:spPr>
              <a:xfrm rot="18600000">
                <a:off x="1987920" y="2539440"/>
                <a:ext cx="639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LE &lt; 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CasellaDiTesto 31"/>
              <p:cNvSpPr/>
              <p:nvPr/>
            </p:nvSpPr>
            <p:spPr>
              <a:xfrm rot="18600000">
                <a:off x="2500560" y="2534400"/>
                <a:ext cx="63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LE ≥ 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CasellaDiTesto 32"/>
              <p:cNvSpPr/>
              <p:nvPr/>
            </p:nvSpPr>
            <p:spPr>
              <a:xfrm rot="18600000">
                <a:off x="1577880" y="2437920"/>
                <a:ext cx="412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" name="Gruppo 2"/>
              <p:cNvGrpSpPr/>
              <p:nvPr/>
            </p:nvGrpSpPr>
            <p:grpSpPr>
              <a:xfrm>
                <a:off x="348120" y="1388880"/>
                <a:ext cx="2865240" cy="433440"/>
                <a:chOff x="348120" y="1388880"/>
                <a:chExt cx="2865240" cy="433440"/>
              </a:xfrm>
            </p:grpSpPr>
            <p:pic>
              <p:nvPicPr>
                <p:cNvPr id="50" name="Picture 2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621080" y="1388880"/>
                  <a:ext cx="1592280" cy="433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" name="CasellaDiTesto 27"/>
                <p:cNvSpPr/>
                <p:nvPr/>
              </p:nvSpPr>
              <p:spPr>
                <a:xfrm>
                  <a:off x="348120" y="1527120"/>
                  <a:ext cx="4262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ER</a:t>
                  </a:r>
                  <a:r>
                    <a:rPr b="1" lang="el-GR" sz="1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2" name="Connettore 2 35"/>
                <p:cNvCxnSpPr/>
                <p:nvPr/>
              </p:nvCxnSpPr>
              <p:spPr>
                <a:xfrm>
                  <a:off x="1096560" y="1684080"/>
                  <a:ext cx="346680" cy="1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53" name="CasellaDiTesto 36"/>
                <p:cNvSpPr/>
                <p:nvPr/>
              </p:nvSpPr>
              <p:spPr>
                <a:xfrm>
                  <a:off x="956160" y="1412640"/>
                  <a:ext cx="587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6 kD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" name="Gruppo 3"/>
              <p:cNvGrpSpPr/>
              <p:nvPr/>
            </p:nvGrpSpPr>
            <p:grpSpPr>
              <a:xfrm>
                <a:off x="337320" y="861840"/>
                <a:ext cx="2876040" cy="396720"/>
                <a:chOff x="337320" y="861840"/>
                <a:chExt cx="2876040" cy="396720"/>
              </a:xfrm>
            </p:grpSpPr>
            <p:pic>
              <p:nvPicPr>
                <p:cNvPr id="55" name="Picture 3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621080" y="920520"/>
                  <a:ext cx="1592280" cy="338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6" name="CasellaDiTesto 28"/>
                <p:cNvSpPr/>
                <p:nvPr/>
              </p:nvSpPr>
              <p:spPr>
                <a:xfrm>
                  <a:off x="337320" y="960120"/>
                  <a:ext cx="4352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ER</a:t>
                  </a:r>
                  <a:r>
                    <a:rPr b="1" lang="el-GR" sz="1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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7" name="Connettore 2 37"/>
                <p:cNvCxnSpPr/>
                <p:nvPr/>
              </p:nvCxnSpPr>
              <p:spPr>
                <a:xfrm>
                  <a:off x="1093320" y="1131480"/>
                  <a:ext cx="347760" cy="1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58" name="CasellaDiTesto 38"/>
                <p:cNvSpPr/>
                <p:nvPr/>
              </p:nvSpPr>
              <p:spPr>
                <a:xfrm>
                  <a:off x="954000" y="861840"/>
                  <a:ext cx="587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46 kD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cxnSp>
            <p:nvCxnSpPr>
              <p:cNvPr id="59" name="Connettore 2 39"/>
              <p:cNvCxnSpPr/>
              <p:nvPr/>
            </p:nvCxnSpPr>
            <p:spPr>
              <a:xfrm>
                <a:off x="1099800" y="2104560"/>
                <a:ext cx="347760" cy="10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60" name="CasellaDiTesto 40"/>
              <p:cNvSpPr/>
              <p:nvPr/>
            </p:nvSpPr>
            <p:spPr>
              <a:xfrm>
                <a:off x="959400" y="1807920"/>
                <a:ext cx="587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6 kD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Gruppo 3"/>
            <p:cNvGrpSpPr/>
            <p:nvPr/>
          </p:nvGrpSpPr>
          <p:grpSpPr>
            <a:xfrm>
              <a:off x="3616920" y="564840"/>
              <a:ext cx="3048840" cy="2029320"/>
              <a:chOff x="3616920" y="564840"/>
              <a:chExt cx="3048840" cy="2029320"/>
            </a:xfrm>
          </p:grpSpPr>
          <p:graphicFrame>
            <p:nvGraphicFramePr>
              <p:cNvPr id="62" name="Oggetto 41"/>
              <p:cNvGraphicFramePr/>
              <p:nvPr/>
            </p:nvGraphicFramePr>
            <p:xfrm>
              <a:off x="3616920" y="564840"/>
              <a:ext cx="2625480" cy="1886400"/>
            </p:xfrm>
            <a:graphic>
              <a:graphicData uri="http://schemas.openxmlformats.org/presentationml/2006/ole">
                <p:oleObj r:id="rId4" spid="">
                  <p:embed/>
                  <p:pic>
                    <p:nvPicPr>
                      <p:cNvPr id="63" name="Oggetto 41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3616920" y="564840"/>
                        <a:ext cx="2625480" cy="18864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64" name="CasellaDiTesto 42"/>
              <p:cNvSpPr/>
              <p:nvPr/>
            </p:nvSpPr>
            <p:spPr>
              <a:xfrm>
                <a:off x="4365720" y="2347920"/>
                <a:ext cx="435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</a:t>
                </a:r>
                <a:r>
                  <a:rPr b="1" lang="el-GR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CasellaDiTesto 43"/>
              <p:cNvSpPr/>
              <p:nvPr/>
            </p:nvSpPr>
            <p:spPr>
              <a:xfrm>
                <a:off x="5281920" y="2347920"/>
                <a:ext cx="42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</a:t>
                </a:r>
                <a:r>
                  <a:rPr b="1" lang="el-GR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CasellaDiTesto 4"/>
              <p:cNvSpPr/>
              <p:nvPr/>
            </p:nvSpPr>
            <p:spPr>
              <a:xfrm>
                <a:off x="5662800" y="1542960"/>
                <a:ext cx="240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CasellaDiTesto 1"/>
              <p:cNvSpPr/>
              <p:nvPr/>
            </p:nvSpPr>
            <p:spPr>
              <a:xfrm>
                <a:off x="6034320" y="588600"/>
                <a:ext cx="412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t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CasellaDiTesto 27"/>
              <p:cNvSpPr/>
              <p:nvPr/>
            </p:nvSpPr>
            <p:spPr>
              <a:xfrm>
                <a:off x="6026400" y="750600"/>
                <a:ext cx="639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SLE &lt; 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CasellaDiTesto 28"/>
              <p:cNvSpPr/>
              <p:nvPr/>
            </p:nvSpPr>
            <p:spPr>
              <a:xfrm>
                <a:off x="6025680" y="899640"/>
                <a:ext cx="63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SLE ≥ 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0" name="CasellaDiTesto 29"/>
            <p:cNvSpPr/>
            <p:nvPr/>
          </p:nvSpPr>
          <p:spPr>
            <a:xfrm>
              <a:off x="256320" y="3985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CasellaDiTesto 30"/>
            <p:cNvSpPr/>
            <p:nvPr/>
          </p:nvSpPr>
          <p:spPr>
            <a:xfrm>
              <a:off x="3500280" y="3952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CasellaDiTesto 32"/>
          <p:cNvSpPr/>
          <p:nvPr/>
        </p:nvSpPr>
        <p:spPr>
          <a:xfrm>
            <a:off x="6043680" y="8831160"/>
            <a:ext cx="77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4-08T13:45:32Z</dcterms:created>
  <dc:creator>Pierdominici Marina</dc:creator>
  <dc:description/>
  <dc:language>en-US</dc:language>
  <cp:lastModifiedBy>Pierdominici Marina</cp:lastModifiedBy>
  <cp:lastPrinted>2015-04-09T12:46:42Z</cp:lastPrinted>
  <dcterms:modified xsi:type="dcterms:W3CDTF">2015-12-09T11:42:07Z</dcterms:modified>
  <cp:revision>62</cp:revision>
  <dc:subject/>
  <dc:title>Presentazione standard di PowerPoint</dc:title>
</cp:coreProperties>
</file>